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  <p:sldId id="265" r:id="rId4"/>
    <p:sldId id="266" r:id="rId5"/>
    <p:sldId id="267" r:id="rId6"/>
    <p:sldId id="268" r:id="rId7"/>
    <p:sldId id="269" r:id="rId8"/>
    <p:sldId id="270" r:id="rId9"/>
    <p:sldId id="271" r:id="rId10"/>
    <p:sldId id="261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829FC78-F162-47EB-8497-2447973ADC36}" v="58" dt="2024-01-12T06:29:58.1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>
        <p:scale>
          <a:sx n="61" d="100"/>
          <a:sy n="61" d="100"/>
        </p:scale>
        <p:origin x="8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ha Ahmed Mousa" userId="c4977515-24c9-48f3-b89d-7b365581966c" providerId="ADAL" clId="{3829FC78-F162-47EB-8497-2447973ADC36}"/>
    <pc:docChg chg="undo custSel addSld delSld modSld">
      <pc:chgData name="Noha Ahmed Mousa" userId="c4977515-24c9-48f3-b89d-7b365581966c" providerId="ADAL" clId="{3829FC78-F162-47EB-8497-2447973ADC36}" dt="2024-01-12T06:29:58.119" v="836" actId="1076"/>
      <pc:docMkLst>
        <pc:docMk/>
      </pc:docMkLst>
      <pc:sldChg chg="modSp add mod">
        <pc:chgData name="Noha Ahmed Mousa" userId="c4977515-24c9-48f3-b89d-7b365581966c" providerId="ADAL" clId="{3829FC78-F162-47EB-8497-2447973ADC36}" dt="2024-01-12T06:29:58.119" v="836" actId="1076"/>
        <pc:sldMkLst>
          <pc:docMk/>
          <pc:sldMk cId="4187594342" sldId="261"/>
        </pc:sldMkLst>
        <pc:spChg chg="mod">
          <ac:chgData name="Noha Ahmed Mousa" userId="c4977515-24c9-48f3-b89d-7b365581966c" providerId="ADAL" clId="{3829FC78-F162-47EB-8497-2447973ADC36}" dt="2024-01-12T06:29:58.119" v="836" actId="1076"/>
          <ac:spMkLst>
            <pc:docMk/>
            <pc:sldMk cId="4187594342" sldId="261"/>
            <ac:spMk id="3" creationId="{99F2EB3B-6746-8AB1-55D1-3DBA24ECA80E}"/>
          </ac:spMkLst>
        </pc:spChg>
        <pc:spChg chg="mod">
          <ac:chgData name="Noha Ahmed Mousa" userId="c4977515-24c9-48f3-b89d-7b365581966c" providerId="ADAL" clId="{3829FC78-F162-47EB-8497-2447973ADC36}" dt="2024-01-12T06:29:58.119" v="836" actId="1076"/>
          <ac:spMkLst>
            <pc:docMk/>
            <pc:sldMk cId="4187594342" sldId="261"/>
            <ac:spMk id="8" creationId="{5F106028-8A76-1907-32EA-83B83466B918}"/>
          </ac:spMkLst>
        </pc:spChg>
        <pc:spChg chg="mod">
          <ac:chgData name="Noha Ahmed Mousa" userId="c4977515-24c9-48f3-b89d-7b365581966c" providerId="ADAL" clId="{3829FC78-F162-47EB-8497-2447973ADC36}" dt="2024-01-12T06:29:58.119" v="836" actId="1076"/>
          <ac:spMkLst>
            <pc:docMk/>
            <pc:sldMk cId="4187594342" sldId="261"/>
            <ac:spMk id="14" creationId="{A930CF8B-A3AC-0DF4-1577-FDA92A005AEF}"/>
          </ac:spMkLst>
        </pc:spChg>
        <pc:spChg chg="mod">
          <ac:chgData name="Noha Ahmed Mousa" userId="c4977515-24c9-48f3-b89d-7b365581966c" providerId="ADAL" clId="{3829FC78-F162-47EB-8497-2447973ADC36}" dt="2024-01-12T06:24:31.499" v="834" actId="1035"/>
          <ac:spMkLst>
            <pc:docMk/>
            <pc:sldMk cId="4187594342" sldId="261"/>
            <ac:spMk id="18" creationId="{BB21F8C4-527B-C106-6DA0-31DA5FFB4729}"/>
          </ac:spMkLst>
        </pc:spChg>
        <pc:grpChg chg="mod">
          <ac:chgData name="Noha Ahmed Mousa" userId="c4977515-24c9-48f3-b89d-7b365581966c" providerId="ADAL" clId="{3829FC78-F162-47EB-8497-2447973ADC36}" dt="2024-01-12T06:29:58.119" v="836" actId="1076"/>
          <ac:grpSpMkLst>
            <pc:docMk/>
            <pc:sldMk cId="4187594342" sldId="261"/>
            <ac:grpSpMk id="17" creationId="{08F9D13D-DC88-EB72-EAB7-ADB5F414C4BC}"/>
          </ac:grpSpMkLst>
        </pc:grpChg>
        <pc:picChg chg="mod">
          <ac:chgData name="Noha Ahmed Mousa" userId="c4977515-24c9-48f3-b89d-7b365581966c" providerId="ADAL" clId="{3829FC78-F162-47EB-8497-2447973ADC36}" dt="2024-01-12T06:29:58.119" v="836" actId="1076"/>
          <ac:picMkLst>
            <pc:docMk/>
            <pc:sldMk cId="4187594342" sldId="261"/>
            <ac:picMk id="7" creationId="{85FB2A55-AA16-BF0D-C779-F48BA3F416A5}"/>
          </ac:picMkLst>
        </pc:picChg>
        <pc:picChg chg="mod">
          <ac:chgData name="Noha Ahmed Mousa" userId="c4977515-24c9-48f3-b89d-7b365581966c" providerId="ADAL" clId="{3829FC78-F162-47EB-8497-2447973ADC36}" dt="2024-01-12T06:29:58.119" v="836" actId="1076"/>
          <ac:picMkLst>
            <pc:docMk/>
            <pc:sldMk cId="4187594342" sldId="261"/>
            <ac:picMk id="11" creationId="{3CBBCCB8-1AE3-7DFC-7602-CA44D5F20367}"/>
          </ac:picMkLst>
        </pc:picChg>
        <pc:picChg chg="mod">
          <ac:chgData name="Noha Ahmed Mousa" userId="c4977515-24c9-48f3-b89d-7b365581966c" providerId="ADAL" clId="{3829FC78-F162-47EB-8497-2447973ADC36}" dt="2024-01-12T06:29:58.119" v="836" actId="1076"/>
          <ac:picMkLst>
            <pc:docMk/>
            <pc:sldMk cId="4187594342" sldId="261"/>
            <ac:picMk id="13" creationId="{D0B42DBC-18C8-E450-0BB0-7CE71E867845}"/>
          </ac:picMkLst>
        </pc:picChg>
        <pc:picChg chg="mod">
          <ac:chgData name="Noha Ahmed Mousa" userId="c4977515-24c9-48f3-b89d-7b365581966c" providerId="ADAL" clId="{3829FC78-F162-47EB-8497-2447973ADC36}" dt="2024-01-12T06:29:58.119" v="836" actId="1076"/>
          <ac:picMkLst>
            <pc:docMk/>
            <pc:sldMk cId="4187594342" sldId="261"/>
            <ac:picMk id="16" creationId="{5267BFE0-4BC1-78A2-1C34-8B38DD5D8B60}"/>
          </ac:picMkLst>
        </pc:picChg>
      </pc:sldChg>
      <pc:sldChg chg="addSp modSp mod">
        <pc:chgData name="Noha Ahmed Mousa" userId="c4977515-24c9-48f3-b89d-7b365581966c" providerId="ADAL" clId="{3829FC78-F162-47EB-8497-2447973ADC36}" dt="2024-01-12T06:22:33.387" v="747" actId="20577"/>
        <pc:sldMkLst>
          <pc:docMk/>
          <pc:sldMk cId="3782576042" sldId="263"/>
        </pc:sldMkLst>
        <pc:spChg chg="mod">
          <ac:chgData name="Noha Ahmed Mousa" userId="c4977515-24c9-48f3-b89d-7b365581966c" providerId="ADAL" clId="{3829FC78-F162-47EB-8497-2447973ADC36}" dt="2024-01-10T12:08:41.020" v="559" actId="20577"/>
          <ac:spMkLst>
            <pc:docMk/>
            <pc:sldMk cId="3782576042" sldId="263"/>
            <ac:spMk id="2" creationId="{EDC0A2B0-4CB5-3362-1B6B-25A9C0A6DD82}"/>
          </ac:spMkLst>
        </pc:spChg>
        <pc:spChg chg="mod">
          <ac:chgData name="Noha Ahmed Mousa" userId="c4977515-24c9-48f3-b89d-7b365581966c" providerId="ADAL" clId="{3829FC78-F162-47EB-8497-2447973ADC36}" dt="2024-01-12T06:22:33.387" v="747" actId="20577"/>
          <ac:spMkLst>
            <pc:docMk/>
            <pc:sldMk cId="3782576042" sldId="263"/>
            <ac:spMk id="3" creationId="{A1F8ECD7-4AF8-DEF4-11FB-F4FCCCAE2952}"/>
          </ac:spMkLst>
        </pc:spChg>
        <pc:spChg chg="add mod">
          <ac:chgData name="Noha Ahmed Mousa" userId="c4977515-24c9-48f3-b89d-7b365581966c" providerId="ADAL" clId="{3829FC78-F162-47EB-8497-2447973ADC36}" dt="2024-01-10T12:08:26.856" v="538" actId="14100"/>
          <ac:spMkLst>
            <pc:docMk/>
            <pc:sldMk cId="3782576042" sldId="263"/>
            <ac:spMk id="5" creationId="{C27E744B-975C-FA9D-25BD-83CEE20EBD7A}"/>
          </ac:spMkLst>
        </pc:spChg>
      </pc:sldChg>
      <pc:sldChg chg="modSp mod">
        <pc:chgData name="Noha Ahmed Mousa" userId="c4977515-24c9-48f3-b89d-7b365581966c" providerId="ADAL" clId="{3829FC78-F162-47EB-8497-2447973ADC36}" dt="2024-01-10T11:54:32.552" v="425" actId="20577"/>
        <pc:sldMkLst>
          <pc:docMk/>
          <pc:sldMk cId="901024537" sldId="264"/>
        </pc:sldMkLst>
        <pc:spChg chg="mod">
          <ac:chgData name="Noha Ahmed Mousa" userId="c4977515-24c9-48f3-b89d-7b365581966c" providerId="ADAL" clId="{3829FC78-F162-47EB-8497-2447973ADC36}" dt="2024-01-10T11:54:32.552" v="425" actId="20577"/>
          <ac:spMkLst>
            <pc:docMk/>
            <pc:sldMk cId="901024537" sldId="264"/>
            <ac:spMk id="14" creationId="{F7B5DF37-3D08-C897-13E5-79723AD28BE2}"/>
          </ac:spMkLst>
        </pc:spChg>
      </pc:sldChg>
      <pc:sldChg chg="addSp delSp modSp new mod">
        <pc:chgData name="Noha Ahmed Mousa" userId="c4977515-24c9-48f3-b89d-7b365581966c" providerId="ADAL" clId="{3829FC78-F162-47EB-8497-2447973ADC36}" dt="2024-01-10T12:23:04.718" v="700" actId="1076"/>
        <pc:sldMkLst>
          <pc:docMk/>
          <pc:sldMk cId="2617284578" sldId="265"/>
        </pc:sldMkLst>
        <pc:spChg chg="add del mod">
          <ac:chgData name="Noha Ahmed Mousa" userId="c4977515-24c9-48f3-b89d-7b365581966c" providerId="ADAL" clId="{3829FC78-F162-47EB-8497-2447973ADC36}" dt="2024-01-10T10:11:54.405" v="136"/>
          <ac:spMkLst>
            <pc:docMk/>
            <pc:sldMk cId="2617284578" sldId="265"/>
            <ac:spMk id="11" creationId="{AD0572EA-6F89-7FAE-A950-4A0DD4DFE6B6}"/>
          </ac:spMkLst>
        </pc:spChg>
        <pc:spChg chg="add mod">
          <ac:chgData name="Noha Ahmed Mousa" userId="c4977515-24c9-48f3-b89d-7b365581966c" providerId="ADAL" clId="{3829FC78-F162-47EB-8497-2447973ADC36}" dt="2024-01-10T12:23:04.718" v="700" actId="1076"/>
          <ac:spMkLst>
            <pc:docMk/>
            <pc:sldMk cId="2617284578" sldId="265"/>
            <ac:spMk id="12" creationId="{6B7C5018-76DB-9BC5-53C6-115561F08F07}"/>
          </ac:spMkLst>
        </pc:spChg>
        <pc:spChg chg="add del mod">
          <ac:chgData name="Noha Ahmed Mousa" userId="c4977515-24c9-48f3-b89d-7b365581966c" providerId="ADAL" clId="{3829FC78-F162-47EB-8497-2447973ADC36}" dt="2024-01-10T10:10:18.445" v="75"/>
          <ac:spMkLst>
            <pc:docMk/>
            <pc:sldMk cId="2617284578" sldId="265"/>
            <ac:spMk id="13" creationId="{7392DBD0-347D-4C18-0F51-B8DBF93410D1}"/>
          </ac:spMkLst>
        </pc:spChg>
        <pc:picChg chg="add mod modCrop">
          <ac:chgData name="Noha Ahmed Mousa" userId="c4977515-24c9-48f3-b89d-7b365581966c" providerId="ADAL" clId="{3829FC78-F162-47EB-8497-2447973ADC36}" dt="2024-01-10T10:08:58.748" v="64" actId="14100"/>
          <ac:picMkLst>
            <pc:docMk/>
            <pc:sldMk cId="2617284578" sldId="265"/>
            <ac:picMk id="3" creationId="{9C164FA9-441C-D62C-F02B-B3322FD36564}"/>
          </ac:picMkLst>
        </pc:picChg>
        <pc:picChg chg="add mod">
          <ac:chgData name="Noha Ahmed Mousa" userId="c4977515-24c9-48f3-b89d-7b365581966c" providerId="ADAL" clId="{3829FC78-F162-47EB-8497-2447973ADC36}" dt="2024-01-10T10:09:15.052" v="68" actId="14100"/>
          <ac:picMkLst>
            <pc:docMk/>
            <pc:sldMk cId="2617284578" sldId="265"/>
            <ac:picMk id="5" creationId="{716D8029-686F-9CAA-6542-B58C4163AAE5}"/>
          </ac:picMkLst>
        </pc:picChg>
        <pc:picChg chg="add mod">
          <ac:chgData name="Noha Ahmed Mousa" userId="c4977515-24c9-48f3-b89d-7b365581966c" providerId="ADAL" clId="{3829FC78-F162-47EB-8497-2447973ADC36}" dt="2024-01-10T10:09:04.786" v="66" actId="14100"/>
          <ac:picMkLst>
            <pc:docMk/>
            <pc:sldMk cId="2617284578" sldId="265"/>
            <ac:picMk id="7" creationId="{D8F0D40A-4DC6-1B29-D239-ABEB10528689}"/>
          </ac:picMkLst>
        </pc:picChg>
        <pc:picChg chg="add mod modCrop">
          <ac:chgData name="Noha Ahmed Mousa" userId="c4977515-24c9-48f3-b89d-7b365581966c" providerId="ADAL" clId="{3829FC78-F162-47EB-8497-2447973ADC36}" dt="2024-01-10T10:09:18.645" v="69" actId="14100"/>
          <ac:picMkLst>
            <pc:docMk/>
            <pc:sldMk cId="2617284578" sldId="265"/>
            <ac:picMk id="9" creationId="{A5F65D35-DE63-639F-CFB0-2B73A395B46D}"/>
          </ac:picMkLst>
        </pc:picChg>
      </pc:sldChg>
      <pc:sldChg chg="addSp delSp modSp new mod">
        <pc:chgData name="Noha Ahmed Mousa" userId="c4977515-24c9-48f3-b89d-7b365581966c" providerId="ADAL" clId="{3829FC78-F162-47EB-8497-2447973ADC36}" dt="2024-01-10T11:54:19.230" v="422" actId="207"/>
        <pc:sldMkLst>
          <pc:docMk/>
          <pc:sldMk cId="3683765840" sldId="266"/>
        </pc:sldMkLst>
        <pc:spChg chg="add mod">
          <ac:chgData name="Noha Ahmed Mousa" userId="c4977515-24c9-48f3-b89d-7b365581966c" providerId="ADAL" clId="{3829FC78-F162-47EB-8497-2447973ADC36}" dt="2024-01-10T11:54:19.230" v="422" actId="207"/>
          <ac:spMkLst>
            <pc:docMk/>
            <pc:sldMk cId="3683765840" sldId="266"/>
            <ac:spMk id="10" creationId="{6C42B7C7-0125-8509-07E2-C851F22510F8}"/>
          </ac:spMkLst>
        </pc:spChg>
        <pc:spChg chg="add del mod">
          <ac:chgData name="Noha Ahmed Mousa" userId="c4977515-24c9-48f3-b89d-7b365581966c" providerId="ADAL" clId="{3829FC78-F162-47EB-8497-2447973ADC36}" dt="2024-01-10T10:42:34.143" v="192"/>
          <ac:spMkLst>
            <pc:docMk/>
            <pc:sldMk cId="3683765840" sldId="266"/>
            <ac:spMk id="11" creationId="{56FCC528-1CE1-8CB8-D117-32F35450C9A5}"/>
          </ac:spMkLst>
        </pc:spChg>
        <pc:picChg chg="add mod">
          <ac:chgData name="Noha Ahmed Mousa" userId="c4977515-24c9-48f3-b89d-7b365581966c" providerId="ADAL" clId="{3829FC78-F162-47EB-8497-2447973ADC36}" dt="2024-01-10T10:42:20.720" v="189" actId="1076"/>
          <ac:picMkLst>
            <pc:docMk/>
            <pc:sldMk cId="3683765840" sldId="266"/>
            <ac:picMk id="3" creationId="{6AB3EFB7-69F8-826F-1791-00B7D5AF54DF}"/>
          </ac:picMkLst>
        </pc:picChg>
        <pc:picChg chg="add mod">
          <ac:chgData name="Noha Ahmed Mousa" userId="c4977515-24c9-48f3-b89d-7b365581966c" providerId="ADAL" clId="{3829FC78-F162-47EB-8497-2447973ADC36}" dt="2024-01-10T10:42:05.829" v="184" actId="14100"/>
          <ac:picMkLst>
            <pc:docMk/>
            <pc:sldMk cId="3683765840" sldId="266"/>
            <ac:picMk id="5" creationId="{64C59B2B-30DD-A723-89E0-C9AFD892F8D4}"/>
          </ac:picMkLst>
        </pc:picChg>
        <pc:picChg chg="add mod">
          <ac:chgData name="Noha Ahmed Mousa" userId="c4977515-24c9-48f3-b89d-7b365581966c" providerId="ADAL" clId="{3829FC78-F162-47EB-8497-2447973ADC36}" dt="2024-01-10T10:42:18.383" v="188" actId="1076"/>
          <ac:picMkLst>
            <pc:docMk/>
            <pc:sldMk cId="3683765840" sldId="266"/>
            <ac:picMk id="7" creationId="{477A469B-4CC8-59EB-3886-7D70068EB65E}"/>
          </ac:picMkLst>
        </pc:picChg>
        <pc:picChg chg="add mod">
          <ac:chgData name="Noha Ahmed Mousa" userId="c4977515-24c9-48f3-b89d-7b365581966c" providerId="ADAL" clId="{3829FC78-F162-47EB-8497-2447973ADC36}" dt="2024-01-10T10:41:59.110" v="182" actId="1076"/>
          <ac:picMkLst>
            <pc:docMk/>
            <pc:sldMk cId="3683765840" sldId="266"/>
            <ac:picMk id="9" creationId="{CA9D0F27-5A4B-90E7-6DBB-5D47AC803C4E}"/>
          </ac:picMkLst>
        </pc:picChg>
      </pc:sldChg>
      <pc:sldChg chg="addSp delSp modSp new mod">
        <pc:chgData name="Noha Ahmed Mousa" userId="c4977515-24c9-48f3-b89d-7b365581966c" providerId="ADAL" clId="{3829FC78-F162-47EB-8497-2447973ADC36}" dt="2024-01-10T11:58:27.390" v="459" actId="14100"/>
        <pc:sldMkLst>
          <pc:docMk/>
          <pc:sldMk cId="2852902376" sldId="267"/>
        </pc:sldMkLst>
        <pc:spChg chg="add del mod">
          <ac:chgData name="Noha Ahmed Mousa" userId="c4977515-24c9-48f3-b89d-7b365581966c" providerId="ADAL" clId="{3829FC78-F162-47EB-8497-2447973ADC36}" dt="2024-01-10T11:46:43.350" v="349"/>
          <ac:spMkLst>
            <pc:docMk/>
            <pc:sldMk cId="2852902376" sldId="267"/>
            <ac:spMk id="3" creationId="{D23FE2F7-D8F0-1B47-6B74-9EC96D6FD88D}"/>
          </ac:spMkLst>
        </pc:spChg>
        <pc:spChg chg="add mod">
          <ac:chgData name="Noha Ahmed Mousa" userId="c4977515-24c9-48f3-b89d-7b365581966c" providerId="ADAL" clId="{3829FC78-F162-47EB-8497-2447973ADC36}" dt="2024-01-10T11:57:42.635" v="449" actId="208"/>
          <ac:spMkLst>
            <pc:docMk/>
            <pc:sldMk cId="2852902376" sldId="267"/>
            <ac:spMk id="4" creationId="{CCFF146F-3288-A319-2C2C-8C02B82E5692}"/>
          </ac:spMkLst>
        </pc:spChg>
        <pc:spChg chg="add del">
          <ac:chgData name="Noha Ahmed Mousa" userId="c4977515-24c9-48f3-b89d-7b365581966c" providerId="ADAL" clId="{3829FC78-F162-47EB-8497-2447973ADC36}" dt="2024-01-10T11:52:58.454" v="398" actId="478"/>
          <ac:spMkLst>
            <pc:docMk/>
            <pc:sldMk cId="2852902376" sldId="267"/>
            <ac:spMk id="16" creationId="{AC6EE6E8-E3A7-7BBF-853A-5B428EDA2184}"/>
          </ac:spMkLst>
        </pc:spChg>
        <pc:picChg chg="add del mod">
          <ac:chgData name="Noha Ahmed Mousa" userId="c4977515-24c9-48f3-b89d-7b365581966c" providerId="ADAL" clId="{3829FC78-F162-47EB-8497-2447973ADC36}" dt="2024-01-10T11:51:20.952" v="382" actId="478"/>
          <ac:picMkLst>
            <pc:docMk/>
            <pc:sldMk cId="2852902376" sldId="267"/>
            <ac:picMk id="6" creationId="{C0B94A9A-2578-C118-E42D-7BCE3CE80202}"/>
          </ac:picMkLst>
        </pc:picChg>
        <pc:picChg chg="add del mod">
          <ac:chgData name="Noha Ahmed Mousa" userId="c4977515-24c9-48f3-b89d-7b365581966c" providerId="ADAL" clId="{3829FC78-F162-47EB-8497-2447973ADC36}" dt="2024-01-10T11:51:21.608" v="383" actId="478"/>
          <ac:picMkLst>
            <pc:docMk/>
            <pc:sldMk cId="2852902376" sldId="267"/>
            <ac:picMk id="8" creationId="{62D18B16-E35E-CE4B-CE71-B76DEE83CCA3}"/>
          </ac:picMkLst>
        </pc:picChg>
        <pc:picChg chg="add mod">
          <ac:chgData name="Noha Ahmed Mousa" userId="c4977515-24c9-48f3-b89d-7b365581966c" providerId="ADAL" clId="{3829FC78-F162-47EB-8497-2447973ADC36}" dt="2024-01-10T11:58:27.390" v="459" actId="14100"/>
          <ac:picMkLst>
            <pc:docMk/>
            <pc:sldMk cId="2852902376" sldId="267"/>
            <ac:picMk id="10" creationId="{72E8135D-8DF9-97EA-717D-24DF02F9FC73}"/>
          </ac:picMkLst>
        </pc:picChg>
        <pc:picChg chg="add mod modCrop">
          <ac:chgData name="Noha Ahmed Mousa" userId="c4977515-24c9-48f3-b89d-7b365581966c" providerId="ADAL" clId="{3829FC78-F162-47EB-8497-2447973ADC36}" dt="2024-01-10T11:58:16.087" v="456" actId="1076"/>
          <ac:picMkLst>
            <pc:docMk/>
            <pc:sldMk cId="2852902376" sldId="267"/>
            <ac:picMk id="12" creationId="{C2E86188-553B-0894-A59B-A387A0A7E982}"/>
          </ac:picMkLst>
        </pc:picChg>
        <pc:picChg chg="add mod">
          <ac:chgData name="Noha Ahmed Mousa" userId="c4977515-24c9-48f3-b89d-7b365581966c" providerId="ADAL" clId="{3829FC78-F162-47EB-8497-2447973ADC36}" dt="2024-01-10T11:58:03.021" v="454" actId="14100"/>
          <ac:picMkLst>
            <pc:docMk/>
            <pc:sldMk cId="2852902376" sldId="267"/>
            <ac:picMk id="14" creationId="{1D9BDAD0-CDFE-0D76-8109-34C1A210A023}"/>
          </ac:picMkLst>
        </pc:picChg>
        <pc:picChg chg="add mod">
          <ac:chgData name="Noha Ahmed Mousa" userId="c4977515-24c9-48f3-b89d-7b365581966c" providerId="ADAL" clId="{3829FC78-F162-47EB-8497-2447973ADC36}" dt="2024-01-10T11:57:57.458" v="453" actId="14100"/>
          <ac:picMkLst>
            <pc:docMk/>
            <pc:sldMk cId="2852902376" sldId="267"/>
            <ac:picMk id="18" creationId="{24585974-440D-EDC0-B64A-8C571A1C9891}"/>
          </ac:picMkLst>
        </pc:picChg>
      </pc:sldChg>
      <pc:sldChg chg="addSp modSp new mod">
        <pc:chgData name="Noha Ahmed Mousa" userId="c4977515-24c9-48f3-b89d-7b365581966c" providerId="ADAL" clId="{3829FC78-F162-47EB-8497-2447973ADC36}" dt="2024-01-10T12:00:27.969" v="483" actId="20577"/>
        <pc:sldMkLst>
          <pc:docMk/>
          <pc:sldMk cId="997998122" sldId="268"/>
        </pc:sldMkLst>
        <pc:spChg chg="add mod">
          <ac:chgData name="Noha Ahmed Mousa" userId="c4977515-24c9-48f3-b89d-7b365581966c" providerId="ADAL" clId="{3829FC78-F162-47EB-8497-2447973ADC36}" dt="2024-01-10T12:00:27.969" v="483" actId="20577"/>
          <ac:spMkLst>
            <pc:docMk/>
            <pc:sldMk cId="997998122" sldId="268"/>
            <ac:spMk id="10" creationId="{AECB4B5E-EAB4-6AB1-6C29-7ACAC1CB352E}"/>
          </ac:spMkLst>
        </pc:spChg>
        <pc:picChg chg="add mod">
          <ac:chgData name="Noha Ahmed Mousa" userId="c4977515-24c9-48f3-b89d-7b365581966c" providerId="ADAL" clId="{3829FC78-F162-47EB-8497-2447973ADC36}" dt="2024-01-10T11:59:18.411" v="472" actId="14100"/>
          <ac:picMkLst>
            <pc:docMk/>
            <pc:sldMk cId="997998122" sldId="268"/>
            <ac:picMk id="3" creationId="{F0291C19-D96B-C4C7-E45E-BBAEE9EFA786}"/>
          </ac:picMkLst>
        </pc:picChg>
        <pc:picChg chg="add mod">
          <ac:chgData name="Noha Ahmed Mousa" userId="c4977515-24c9-48f3-b89d-7b365581966c" providerId="ADAL" clId="{3829FC78-F162-47EB-8497-2447973ADC36}" dt="2024-01-10T11:56:12.845" v="435" actId="1076"/>
          <ac:picMkLst>
            <pc:docMk/>
            <pc:sldMk cId="997998122" sldId="268"/>
            <ac:picMk id="5" creationId="{20739F24-3C7F-3164-8604-6565AFD7EB7E}"/>
          </ac:picMkLst>
        </pc:picChg>
        <pc:picChg chg="add mod">
          <ac:chgData name="Noha Ahmed Mousa" userId="c4977515-24c9-48f3-b89d-7b365581966c" providerId="ADAL" clId="{3829FC78-F162-47EB-8497-2447973ADC36}" dt="2024-01-10T11:59:21.785" v="473" actId="1076"/>
          <ac:picMkLst>
            <pc:docMk/>
            <pc:sldMk cId="997998122" sldId="268"/>
            <ac:picMk id="7" creationId="{B1EF9F20-AE8C-629C-51D7-AFB6BAC608C3}"/>
          </ac:picMkLst>
        </pc:picChg>
        <pc:picChg chg="add mod modCrop">
          <ac:chgData name="Noha Ahmed Mousa" userId="c4977515-24c9-48f3-b89d-7b365581966c" providerId="ADAL" clId="{3829FC78-F162-47EB-8497-2447973ADC36}" dt="2024-01-10T11:59:02.185" v="466" actId="1076"/>
          <ac:picMkLst>
            <pc:docMk/>
            <pc:sldMk cId="997998122" sldId="268"/>
            <ac:picMk id="9" creationId="{5CC634E1-F396-E2DC-C1B2-53B9734BD722}"/>
          </ac:picMkLst>
        </pc:picChg>
      </pc:sldChg>
      <pc:sldChg chg="addSp modSp new mod">
        <pc:chgData name="Noha Ahmed Mousa" userId="c4977515-24c9-48f3-b89d-7b365581966c" providerId="ADAL" clId="{3829FC78-F162-47EB-8497-2447973ADC36}" dt="2024-01-10T12:06:59.129" v="516" actId="13926"/>
        <pc:sldMkLst>
          <pc:docMk/>
          <pc:sldMk cId="1462534208" sldId="269"/>
        </pc:sldMkLst>
        <pc:spChg chg="add mod">
          <ac:chgData name="Noha Ahmed Mousa" userId="c4977515-24c9-48f3-b89d-7b365581966c" providerId="ADAL" clId="{3829FC78-F162-47EB-8497-2447973ADC36}" dt="2024-01-10T12:06:59.129" v="516" actId="13926"/>
          <ac:spMkLst>
            <pc:docMk/>
            <pc:sldMk cId="1462534208" sldId="269"/>
            <ac:spMk id="10" creationId="{32566743-5C0C-9419-0C41-B7FA6E976B73}"/>
          </ac:spMkLst>
        </pc:spChg>
        <pc:picChg chg="add mod">
          <ac:chgData name="Noha Ahmed Mousa" userId="c4977515-24c9-48f3-b89d-7b365581966c" providerId="ADAL" clId="{3829FC78-F162-47EB-8497-2447973ADC36}" dt="2024-01-10T12:03:13.882" v="487" actId="1076"/>
          <ac:picMkLst>
            <pc:docMk/>
            <pc:sldMk cId="1462534208" sldId="269"/>
            <ac:picMk id="3" creationId="{ABED408A-660D-007B-0872-5BDEAFF85DF4}"/>
          </ac:picMkLst>
        </pc:picChg>
        <pc:picChg chg="add mod">
          <ac:chgData name="Noha Ahmed Mousa" userId="c4977515-24c9-48f3-b89d-7b365581966c" providerId="ADAL" clId="{3829FC78-F162-47EB-8497-2447973ADC36}" dt="2024-01-10T12:05:45.266" v="500" actId="1076"/>
          <ac:picMkLst>
            <pc:docMk/>
            <pc:sldMk cId="1462534208" sldId="269"/>
            <ac:picMk id="5" creationId="{1EEC8FAB-E95A-1E7F-AD4B-96E9831CFC50}"/>
          </ac:picMkLst>
        </pc:picChg>
        <pc:picChg chg="add mod">
          <ac:chgData name="Noha Ahmed Mousa" userId="c4977515-24c9-48f3-b89d-7b365581966c" providerId="ADAL" clId="{3829FC78-F162-47EB-8497-2447973ADC36}" dt="2024-01-10T12:05:41.889" v="499" actId="1076"/>
          <ac:picMkLst>
            <pc:docMk/>
            <pc:sldMk cId="1462534208" sldId="269"/>
            <ac:picMk id="7" creationId="{9B79D209-CE55-9C12-FD3A-DE1CE1A3C23B}"/>
          </ac:picMkLst>
        </pc:picChg>
        <pc:picChg chg="add mod">
          <ac:chgData name="Noha Ahmed Mousa" userId="c4977515-24c9-48f3-b89d-7b365581966c" providerId="ADAL" clId="{3829FC78-F162-47EB-8497-2447973ADC36}" dt="2024-01-10T12:05:47.084" v="501" actId="1076"/>
          <ac:picMkLst>
            <pc:docMk/>
            <pc:sldMk cId="1462534208" sldId="269"/>
            <ac:picMk id="9" creationId="{3FD29658-91C2-9A9F-938B-2B9AE551007E}"/>
          </ac:picMkLst>
        </pc:picChg>
      </pc:sldChg>
      <pc:sldChg chg="addSp delSp modSp new mod">
        <pc:chgData name="Noha Ahmed Mousa" userId="c4977515-24c9-48f3-b89d-7b365581966c" providerId="ADAL" clId="{3829FC78-F162-47EB-8497-2447973ADC36}" dt="2024-01-10T12:18:10.626" v="644" actId="1076"/>
        <pc:sldMkLst>
          <pc:docMk/>
          <pc:sldMk cId="265452085" sldId="270"/>
        </pc:sldMkLst>
        <pc:spChg chg="add del mod">
          <ac:chgData name="Noha Ahmed Mousa" userId="c4977515-24c9-48f3-b89d-7b365581966c" providerId="ADAL" clId="{3829FC78-F162-47EB-8497-2447973ADC36}" dt="2024-01-10T12:17:55.374" v="641"/>
          <ac:spMkLst>
            <pc:docMk/>
            <pc:sldMk cId="265452085" sldId="270"/>
            <ac:spMk id="11" creationId="{ECC5E3C0-8B54-9042-A9A8-CE7B584123CB}"/>
          </ac:spMkLst>
        </pc:spChg>
        <pc:spChg chg="add mod">
          <ac:chgData name="Noha Ahmed Mousa" userId="c4977515-24c9-48f3-b89d-7b365581966c" providerId="ADAL" clId="{3829FC78-F162-47EB-8497-2447973ADC36}" dt="2024-01-10T12:18:10.626" v="644" actId="1076"/>
          <ac:spMkLst>
            <pc:docMk/>
            <pc:sldMk cId="265452085" sldId="270"/>
            <ac:spMk id="12" creationId="{E8F016B8-F35A-B537-C58B-65A9526FF0D3}"/>
          </ac:spMkLst>
        </pc:spChg>
        <pc:picChg chg="add mod">
          <ac:chgData name="Noha Ahmed Mousa" userId="c4977515-24c9-48f3-b89d-7b365581966c" providerId="ADAL" clId="{3829FC78-F162-47EB-8497-2447973ADC36}" dt="2024-01-10T12:11:20.970" v="602" actId="14100"/>
          <ac:picMkLst>
            <pc:docMk/>
            <pc:sldMk cId="265452085" sldId="270"/>
            <ac:picMk id="3" creationId="{04C89D18-450A-CA58-FA98-3A01EBF9B835}"/>
          </ac:picMkLst>
        </pc:picChg>
        <pc:picChg chg="add mod">
          <ac:chgData name="Noha Ahmed Mousa" userId="c4977515-24c9-48f3-b89d-7b365581966c" providerId="ADAL" clId="{3829FC78-F162-47EB-8497-2447973ADC36}" dt="2024-01-10T12:16:46.856" v="608" actId="1076"/>
          <ac:picMkLst>
            <pc:docMk/>
            <pc:sldMk cId="265452085" sldId="270"/>
            <ac:picMk id="5" creationId="{13EB9B13-A28B-B01F-133D-895FB5528F90}"/>
          </ac:picMkLst>
        </pc:picChg>
        <pc:picChg chg="add mod">
          <ac:chgData name="Noha Ahmed Mousa" userId="c4977515-24c9-48f3-b89d-7b365581966c" providerId="ADAL" clId="{3829FC78-F162-47EB-8497-2447973ADC36}" dt="2024-01-10T12:11:26.395" v="604" actId="14100"/>
          <ac:picMkLst>
            <pc:docMk/>
            <pc:sldMk cId="265452085" sldId="270"/>
            <ac:picMk id="7" creationId="{453C20C2-1F5E-A86F-8AE5-A46BE2A0C3F0}"/>
          </ac:picMkLst>
        </pc:picChg>
        <pc:picChg chg="add mod">
          <ac:chgData name="Noha Ahmed Mousa" userId="c4977515-24c9-48f3-b89d-7b365581966c" providerId="ADAL" clId="{3829FC78-F162-47EB-8497-2447973ADC36}" dt="2024-01-10T12:16:43.077" v="607" actId="1076"/>
          <ac:picMkLst>
            <pc:docMk/>
            <pc:sldMk cId="265452085" sldId="270"/>
            <ac:picMk id="9" creationId="{56B2B644-AFB5-F6BD-9A8E-27D25A4D1593}"/>
          </ac:picMkLst>
        </pc:picChg>
      </pc:sldChg>
      <pc:sldChg chg="addSp delSp modSp new mod">
        <pc:chgData name="Noha Ahmed Mousa" userId="c4977515-24c9-48f3-b89d-7b365581966c" providerId="ADAL" clId="{3829FC78-F162-47EB-8497-2447973ADC36}" dt="2024-01-10T12:21:44.975" v="696" actId="13926"/>
        <pc:sldMkLst>
          <pc:docMk/>
          <pc:sldMk cId="4107172463" sldId="271"/>
        </pc:sldMkLst>
        <pc:spChg chg="add del">
          <ac:chgData name="Noha Ahmed Mousa" userId="c4977515-24c9-48f3-b89d-7b365581966c" providerId="ADAL" clId="{3829FC78-F162-47EB-8497-2447973ADC36}" dt="2024-01-10T12:18:43.727" v="648" actId="478"/>
          <ac:spMkLst>
            <pc:docMk/>
            <pc:sldMk cId="4107172463" sldId="271"/>
            <ac:spMk id="3" creationId="{ABF566A7-E425-B83C-3ACF-F5E828A98788}"/>
          </ac:spMkLst>
        </pc:spChg>
        <pc:spChg chg="add mod">
          <ac:chgData name="Noha Ahmed Mousa" userId="c4977515-24c9-48f3-b89d-7b365581966c" providerId="ADAL" clId="{3829FC78-F162-47EB-8497-2447973ADC36}" dt="2024-01-10T12:21:44.975" v="696" actId="13926"/>
          <ac:spMkLst>
            <pc:docMk/>
            <pc:sldMk cId="4107172463" sldId="271"/>
            <ac:spMk id="4" creationId="{0789772D-2DE1-E20C-3A98-367C9C1921C4}"/>
          </ac:spMkLst>
        </pc:spChg>
        <pc:picChg chg="add mod">
          <ac:chgData name="Noha Ahmed Mousa" userId="c4977515-24c9-48f3-b89d-7b365581966c" providerId="ADAL" clId="{3829FC78-F162-47EB-8497-2447973ADC36}" dt="2024-01-10T12:20:12.373" v="663" actId="14100"/>
          <ac:picMkLst>
            <pc:docMk/>
            <pc:sldMk cId="4107172463" sldId="271"/>
            <ac:picMk id="6" creationId="{A764F553-A246-3096-307D-D1943C6C5882}"/>
          </ac:picMkLst>
        </pc:picChg>
        <pc:picChg chg="add mod">
          <ac:chgData name="Noha Ahmed Mousa" userId="c4977515-24c9-48f3-b89d-7b365581966c" providerId="ADAL" clId="{3829FC78-F162-47EB-8497-2447973ADC36}" dt="2024-01-10T12:20:09.659" v="662" actId="1076"/>
          <ac:picMkLst>
            <pc:docMk/>
            <pc:sldMk cId="4107172463" sldId="271"/>
            <ac:picMk id="8" creationId="{E2FEBE33-F536-6748-509F-D4FF3BED185F}"/>
          </ac:picMkLst>
        </pc:picChg>
        <pc:picChg chg="add mod">
          <ac:chgData name="Noha Ahmed Mousa" userId="c4977515-24c9-48f3-b89d-7b365581966c" providerId="ADAL" clId="{3829FC78-F162-47EB-8497-2447973ADC36}" dt="2024-01-10T12:20:34.355" v="667" actId="14100"/>
          <ac:picMkLst>
            <pc:docMk/>
            <pc:sldMk cId="4107172463" sldId="271"/>
            <ac:picMk id="10" creationId="{E250AB8F-C2CD-B50B-A417-5BC070B2D715}"/>
          </ac:picMkLst>
        </pc:picChg>
        <pc:picChg chg="add mod">
          <ac:chgData name="Noha Ahmed Mousa" userId="c4977515-24c9-48f3-b89d-7b365581966c" providerId="ADAL" clId="{3829FC78-F162-47EB-8497-2447973ADC36}" dt="2024-01-10T12:21:00.740" v="674" actId="14100"/>
          <ac:picMkLst>
            <pc:docMk/>
            <pc:sldMk cId="4107172463" sldId="271"/>
            <ac:picMk id="12" creationId="{C130CF24-4D86-2DC3-330D-B8336D12CF05}"/>
          </ac:picMkLst>
        </pc:picChg>
      </pc:sldChg>
      <pc:sldChg chg="new del">
        <pc:chgData name="Noha Ahmed Mousa" userId="c4977515-24c9-48f3-b89d-7b365581966c" providerId="ADAL" clId="{3829FC78-F162-47EB-8497-2447973ADC36}" dt="2024-01-12T06:22:57.447" v="750" actId="47"/>
        <pc:sldMkLst>
          <pc:docMk/>
          <pc:sldMk cId="3843781876" sldId="272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E79E9-367A-DBFA-DA25-AE4B8E4963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C704173-08FD-C07D-5225-2BC11BF6AE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EA1F01-DFC4-1A70-D5B6-658A8D7C6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DF2428-42D5-7EB0-6522-374D9DCE4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56C7A1-A69A-F3EC-1890-8FF7007304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964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24E148-E8A4-4DC2-A860-A782BBB1AD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AFC06E-383C-343D-9CDE-37397BAF17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A798F6-6437-7004-7578-1675175FD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5B8DDC-B0E5-6463-711F-0F26871F3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904D58-F1B1-03E5-4FE9-F24EE5A7E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809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4B91E71-7101-E785-303D-9257803AFA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10950D-6BDC-71E9-7862-1E7BAB1917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E95A7B-980D-F0A6-9BC1-D8A5A346F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717129-847C-96AF-D2C1-B073A5FBC9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E29F66-21C7-14BC-5130-6D12774AF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503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DAC3AA-53B8-F0BD-CE89-396E731CAF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E342EF-A73E-70D6-E9D5-3E56B6B8AF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41F6FD-4723-5245-775D-809E2B33DB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DF3075-247F-37AE-62B1-D25CD44EB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54DD1E-5246-44A7-B1F7-9351000F2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321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D7872B-464D-6434-402A-E9F378CD26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8855E9-5479-CCCE-0A68-6F027D5F27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F13518-CFAC-9866-217E-F30D7F365F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391A44-7098-E215-6738-CB505C614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CED792-0343-7B2D-E641-5A5A36CF2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081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5E75C4-538C-6654-A75D-57D384CA9D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1008B7-3752-5821-F343-66F11CAC84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19A229-BA96-5721-D963-6D560C4FA3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899850-25BA-80D4-E575-CD6DE31C72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4E3636-62AF-01AF-A2DF-C3F4517A1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E76902-9DF1-D9E5-3EC2-8CEF3D2CA8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874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C97371-02C2-A208-CCDA-629A68F32C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D0A9B9-4E69-325F-FACE-EE347D6132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7A1B3B-EE8F-4D62-C8DA-56F35BAF70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34680B-966B-0F03-7533-D9D13C783C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EEDBC8-2E65-9865-D9C4-4494EBD6C8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FBC7F8-2FC4-AF9B-3121-B5DB002BD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DA12D07-8BFC-6D37-348D-7C2C186EE6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BDC606-DFC9-8460-B384-B10A49A71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998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D02879-423B-B7E9-5961-03A30EAA9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6BA3C1-C047-2586-B17F-8A7FDE96C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016C9A-52FF-F2D9-BA1C-28B1E3067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EC350F-CD29-BB41-A285-D39B6B7AF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686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15A1644-9D12-7BD5-C983-8017A50D6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103FBC-A22C-26DE-D4B8-457E93AC7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7BD95F-F999-18D3-EF8D-6B24493E5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299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AA0F56-12F8-F2D4-BCD9-092B199F12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5D1EA3-E4A6-B968-6201-02867DF307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29D426-B7EA-FB19-3D93-3767B1DDCF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CCD3DB-87F3-4A00-6210-8385075B5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AF62C2-EABB-4AF0-A45F-D52430E47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B17DA1-8DA9-D307-8C99-5AF54C795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211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5E0B41-FFE7-2D74-0112-1E31651194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674B10-90E9-F8EA-80DC-92F158D073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327C02-2879-3A1A-ACE3-9089B17227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6D2DA3-CD86-8F11-5DA5-AA599FC31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33749E-BE89-B053-D222-8496311E0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3316F9-D0AE-A47E-387A-A81C75A0B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956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927B64-5EA5-DAA3-E5EB-7EE9B19AEF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9BA14A-3C1A-595D-1648-9434C316A3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7F62C1-81D8-823F-AB11-FBE4D3B1D5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09D6EC-ACD9-4094-B233-C948D6B2F86C}" type="datetimeFigureOut">
              <a:rPr lang="en-US" smtClean="0"/>
              <a:t>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1D6CDB-5B44-121C-52DF-A97122EEAB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30CA1E-290E-53F3-5F87-7B5455DB66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BF42CF-1F73-4F4C-83FE-93B7194A1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026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kmplot.com/" TargetMode="External"/><Relationship Id="rId1" Type="http://schemas.openxmlformats.org/officeDocument/2006/relationships/slideLayout" Target="../slideLayouts/slideLayout3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C0A2B0-4CB5-3362-1B6B-25A9C0A6DD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45210" y="2405849"/>
            <a:ext cx="10515600" cy="891706"/>
          </a:xfrm>
        </p:spPr>
        <p:txBody>
          <a:bodyPr>
            <a:normAutofit fontScale="90000"/>
          </a:bodyPr>
          <a:lstStyle/>
          <a:p>
            <a:pPr algn="ctr"/>
            <a:r>
              <a:rPr lang="en-US" dirty="0"/>
              <a:t>Supplemental Data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F8ECD7-4AF8-DEF4-11FB-F4FCCCAE29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45210" y="3560446"/>
            <a:ext cx="10515600" cy="2268854"/>
          </a:xfrm>
        </p:spPr>
        <p:txBody>
          <a:bodyPr>
            <a:normAutofit fontScale="92500" lnSpcReduction="20000"/>
          </a:bodyPr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ALDH1A1 and KI67 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Correlation and Survival Analysis /Various Subtypes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Source References: 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1) KM-Plotter </a:t>
            </a:r>
          </a:p>
          <a:p>
            <a:pPr algn="ctr"/>
            <a:r>
              <a:rPr lang="en-US" b="1" dirty="0">
                <a:solidFill>
                  <a:schemeClr val="tx1"/>
                </a:solidFill>
                <a:hlinkClick r:id="rId2"/>
              </a:rPr>
              <a:t>https://kmplot.com/</a:t>
            </a:r>
            <a:r>
              <a:rPr lang="en-US" b="1" dirty="0">
                <a:solidFill>
                  <a:schemeClr val="tx1"/>
                </a:solidFill>
              </a:rPr>
              <a:t>  (Breast Cancer/RNA-Seq)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2) GENT2 Tool</a:t>
            </a:r>
          </a:p>
          <a:p>
            <a:pPr algn="ctr"/>
            <a:endParaRPr lang="en-US" b="1" dirty="0">
              <a:solidFill>
                <a:schemeClr val="tx1"/>
              </a:solidFill>
            </a:endParaRPr>
          </a:p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27E744B-975C-FA9D-25BD-83CEE20EBD7A}"/>
              </a:ext>
            </a:extLst>
          </p:cNvPr>
          <p:cNvSpPr txBox="1"/>
          <p:nvPr/>
        </p:nvSpPr>
        <p:spPr>
          <a:xfrm>
            <a:off x="228600" y="692743"/>
            <a:ext cx="11258550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e Pluripotency Stem Cell Markers and ALDH1A1 Relevant in the Context of Breast Cancer Estrogen Positivity?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257604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08F9D13D-DC88-EB72-EAB7-ADB5F414C4BC}"/>
              </a:ext>
            </a:extLst>
          </p:cNvPr>
          <p:cNvGrpSpPr/>
          <p:nvPr/>
        </p:nvGrpSpPr>
        <p:grpSpPr>
          <a:xfrm>
            <a:off x="94594" y="63127"/>
            <a:ext cx="9535886" cy="6678387"/>
            <a:chOff x="95088" y="0"/>
            <a:chExt cx="12761985" cy="9327395"/>
          </a:xfrm>
        </p:grpSpPr>
        <p:sp>
          <p:nvSpPr>
            <p:cNvPr id="3" name="AutoShape 4">
              <a:extLst>
                <a:ext uri="{FF2B5EF4-FFF2-40B4-BE49-F238E27FC236}">
                  <a16:creationId xmlns:a16="http://schemas.microsoft.com/office/drawing/2014/main" id="{99F2EB3B-6746-8AB1-55D1-3DBA24ECA80E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5943600" y="3276600"/>
              <a:ext cx="304800" cy="3048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5FB2A55-AA16-BF0D-C779-F48BA3F416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4667" r="27643" b="13524"/>
            <a:stretch/>
          </p:blipFill>
          <p:spPr>
            <a:xfrm>
              <a:off x="95088" y="0"/>
              <a:ext cx="8189985" cy="45720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F106028-8A76-1907-32EA-83B83466B918}"/>
                </a:ext>
              </a:extLst>
            </p:cNvPr>
            <p:cNvSpPr txBox="1"/>
            <p:nvPr/>
          </p:nvSpPr>
          <p:spPr>
            <a:xfrm>
              <a:off x="3394831" y="168155"/>
              <a:ext cx="159050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highlight>
                    <a:srgbClr val="FFFF00"/>
                  </a:highlight>
                </a:rPr>
                <a:t>ALDH1A1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CBBCCB8-1AE3-7DFC-7602-CA44D5F20367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1" t="16052" r="51249" b="5905"/>
            <a:stretch/>
          </p:blipFill>
          <p:spPr>
            <a:xfrm>
              <a:off x="8285073" y="0"/>
              <a:ext cx="4572000" cy="4572000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D0B42DBC-18C8-E450-0BB0-7CE71E8678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15987" r="31869" b="16000"/>
            <a:stretch/>
          </p:blipFill>
          <p:spPr>
            <a:xfrm>
              <a:off x="121071" y="4755395"/>
              <a:ext cx="8142207" cy="4572000"/>
            </a:xfrm>
            <a:prstGeom prst="rect">
              <a:avLst/>
            </a:prstGeom>
            <a:ln w="38100" cap="sq">
              <a:solidFill>
                <a:srgbClr val="0070C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930CF8B-A3AC-0DF4-1577-FDA92A005AEF}"/>
                </a:ext>
              </a:extLst>
            </p:cNvPr>
            <p:cNvSpPr txBox="1"/>
            <p:nvPr/>
          </p:nvSpPr>
          <p:spPr>
            <a:xfrm>
              <a:off x="3535035" y="4755395"/>
              <a:ext cx="115768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highlight>
                    <a:srgbClr val="FFFF00"/>
                  </a:highlight>
                </a:rPr>
                <a:t>MKI67</a:t>
              </a:r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5267BFE0-4BC1-78A2-1C34-8B38DD5D8B60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t="17216" r="50000" b="7317"/>
            <a:stretch/>
          </p:blipFill>
          <p:spPr>
            <a:xfrm>
              <a:off x="8263278" y="4755395"/>
              <a:ext cx="4572000" cy="4572000"/>
            </a:xfrm>
            <a:prstGeom prst="rect">
              <a:avLst/>
            </a:prstGeom>
            <a:ln w="38100" cap="sq">
              <a:solidFill>
                <a:srgbClr val="0070C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BB21F8C4-527B-C106-6DA0-31DA5FFB4729}"/>
              </a:ext>
            </a:extLst>
          </p:cNvPr>
          <p:cNvSpPr txBox="1"/>
          <p:nvPr/>
        </p:nvSpPr>
        <p:spPr>
          <a:xfrm>
            <a:off x="9975670" y="63127"/>
            <a:ext cx="1846217" cy="461665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r>
              <a:rPr lang="en-US" sz="2400" b="1" dirty="0"/>
              <a:t>GENT2 TOOL</a:t>
            </a:r>
          </a:p>
        </p:txBody>
      </p:sp>
    </p:spTree>
    <p:extLst>
      <p:ext uri="{BB962C8B-B14F-4D97-AF65-F5344CB8AC3E}">
        <p14:creationId xmlns:p14="http://schemas.microsoft.com/office/powerpoint/2010/main" val="41875943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E4D45DD-9C14-1BDF-D1EC-03BAB2FBBF0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6448"/>
          <a:stretch/>
        </p:blipFill>
        <p:spPr>
          <a:xfrm>
            <a:off x="5928973" y="0"/>
            <a:ext cx="2977959" cy="3304652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B85F88A-0CD2-0993-89CE-67E29CB76FD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3548"/>
          <a:stretch/>
        </p:blipFill>
        <p:spPr>
          <a:xfrm>
            <a:off x="2341552" y="0"/>
            <a:ext cx="3497111" cy="3324738"/>
          </a:xfrm>
          <a:prstGeom prst="rect">
            <a:avLst/>
          </a:prstGeom>
          <a:ln>
            <a:solidFill>
              <a:schemeClr val="accent2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8A28377-8432-932D-E1FB-0164DD3A856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7186"/>
          <a:stretch/>
        </p:blipFill>
        <p:spPr>
          <a:xfrm>
            <a:off x="5928974" y="3396742"/>
            <a:ext cx="2977959" cy="3304651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47A48DB-DA81-3B8C-7927-299117A7BF6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37419" y="3396742"/>
            <a:ext cx="3505375" cy="3396739"/>
          </a:xfrm>
          <a:prstGeom prst="rect">
            <a:avLst/>
          </a:prstGeom>
          <a:ln>
            <a:solidFill>
              <a:schemeClr val="accent2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7B5DF37-3D08-C897-13E5-79723AD28BE2}"/>
              </a:ext>
            </a:extLst>
          </p:cNvPr>
          <p:cNvSpPr txBox="1"/>
          <p:nvPr/>
        </p:nvSpPr>
        <p:spPr>
          <a:xfrm>
            <a:off x="9071515" y="2125213"/>
            <a:ext cx="2612485" cy="369331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b="1" dirty="0"/>
              <a:t>Spearman’s correlation </a:t>
            </a:r>
            <a:r>
              <a:rPr lang="en-US" dirty="0"/>
              <a:t>ALDH1A1 /KI67</a:t>
            </a:r>
          </a:p>
          <a:p>
            <a:r>
              <a:rPr lang="en-US" b="1" dirty="0">
                <a:highlight>
                  <a:srgbClr val="FFFF00"/>
                </a:highlight>
              </a:rPr>
              <a:t>-0.1523 (p&lt;1E-04)</a:t>
            </a:r>
          </a:p>
          <a:p>
            <a:endParaRPr lang="en-US" dirty="0"/>
          </a:p>
          <a:p>
            <a:r>
              <a:rPr lang="en-US" b="1" dirty="0"/>
              <a:t>Criteria of selected samples</a:t>
            </a:r>
          </a:p>
          <a:p>
            <a:endParaRPr lang="en-US" dirty="0"/>
          </a:p>
          <a:p>
            <a:r>
              <a:rPr lang="en-US" dirty="0"/>
              <a:t>ER+BC</a:t>
            </a:r>
          </a:p>
          <a:p>
            <a:r>
              <a:rPr lang="en-US" dirty="0"/>
              <a:t>Endocrine therapy received</a:t>
            </a:r>
          </a:p>
          <a:p>
            <a:r>
              <a:rPr lang="en-US" dirty="0"/>
              <a:t>All</a:t>
            </a:r>
          </a:p>
          <a:p>
            <a:endParaRPr lang="en-US" dirty="0"/>
          </a:p>
          <a:p>
            <a:r>
              <a:rPr lang="en-US" b="1" dirty="0"/>
              <a:t>N = 2279 cases</a:t>
            </a:r>
          </a:p>
        </p:txBody>
      </p:sp>
      <p:sp>
        <p:nvSpPr>
          <p:cNvPr id="18" name="Rectangle 2">
            <a:extLst>
              <a:ext uri="{FF2B5EF4-FFF2-40B4-BE49-F238E27FC236}">
                <a16:creationId xmlns:a16="http://schemas.microsoft.com/office/drawing/2014/main" id="{F837D0BB-C51D-5742-1A1D-858E0FEEB0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8200" y="381793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10245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C164FA9-441C-D62C-F02B-B3322FD3656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012"/>
          <a:stretch/>
        </p:blipFill>
        <p:spPr>
          <a:xfrm>
            <a:off x="5670060" y="-16940"/>
            <a:ext cx="3541674" cy="3386980"/>
          </a:xfrm>
          <a:prstGeom prst="rect">
            <a:avLst/>
          </a:prstGeom>
          <a:ln>
            <a:solidFill>
              <a:schemeClr val="accent2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16D8029-686F-9CAA-6542-B58C4163AA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8826" y="-37106"/>
            <a:ext cx="3775326" cy="358496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8F0D40A-4DC6-1B29-D239-ABEB105286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70060" y="3487961"/>
            <a:ext cx="3541674" cy="3330638"/>
          </a:xfrm>
          <a:prstGeom prst="rect">
            <a:avLst/>
          </a:prstGeom>
          <a:ln>
            <a:solidFill>
              <a:schemeClr val="accent2">
                <a:lumMod val="40000"/>
                <a:lumOff val="60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5F65D35-DE63-639F-CFB0-2B73A395B46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848"/>
          <a:stretch/>
        </p:blipFill>
        <p:spPr>
          <a:xfrm>
            <a:off x="1798826" y="3547854"/>
            <a:ext cx="3763569" cy="331014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6B7C5018-76DB-9BC5-53C6-115561F08F07}"/>
              </a:ext>
            </a:extLst>
          </p:cNvPr>
          <p:cNvSpPr txBox="1"/>
          <p:nvPr/>
        </p:nvSpPr>
        <p:spPr>
          <a:xfrm>
            <a:off x="9211734" y="1321939"/>
            <a:ext cx="2901244" cy="3416320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b="1" dirty="0"/>
              <a:t>Spearman’s correlation ALDH1A1 /KI67</a:t>
            </a:r>
          </a:p>
          <a:p>
            <a:endParaRPr lang="en-US" dirty="0"/>
          </a:p>
          <a:p>
            <a:r>
              <a:rPr lang="en-US" b="1" i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Verdana" panose="020B0604030504040204" pitchFamily="34" charset="0"/>
              </a:rPr>
              <a:t>-0.1334 (p=0.0013)</a:t>
            </a:r>
            <a:endParaRPr lang="en-US" b="1" dirty="0">
              <a:highlight>
                <a:srgbClr val="FFFF00"/>
              </a:highlight>
            </a:endParaRPr>
          </a:p>
          <a:p>
            <a:endParaRPr lang="en-US" dirty="0"/>
          </a:p>
          <a:p>
            <a:r>
              <a:rPr lang="en-US" b="1" dirty="0"/>
              <a:t>Criteria of selected samples</a:t>
            </a:r>
          </a:p>
          <a:p>
            <a:endParaRPr lang="en-US" dirty="0"/>
          </a:p>
          <a:p>
            <a:r>
              <a:rPr lang="en-US" dirty="0"/>
              <a:t>ER+BC</a:t>
            </a:r>
          </a:p>
          <a:p>
            <a:r>
              <a:rPr lang="en-US" dirty="0"/>
              <a:t>Endocrine therapy received</a:t>
            </a:r>
          </a:p>
          <a:p>
            <a:r>
              <a:rPr lang="en-US" dirty="0">
                <a:solidFill>
                  <a:srgbClr val="C00000"/>
                </a:solidFill>
              </a:rPr>
              <a:t>KI67 positive cases</a:t>
            </a:r>
          </a:p>
          <a:p>
            <a:endParaRPr lang="en-US" dirty="0"/>
          </a:p>
          <a:p>
            <a:r>
              <a:rPr lang="en-US" dirty="0"/>
              <a:t>N = </a:t>
            </a:r>
            <a:r>
              <a:rPr lang="en-US" b="0" i="0" dirty="0">
                <a:solidFill>
                  <a:srgbClr val="000000"/>
                </a:solidFill>
                <a:effectLst/>
                <a:latin typeface="Verdana" panose="020B0604030504040204" pitchFamily="34" charset="0"/>
              </a:rPr>
              <a:t>584 </a:t>
            </a:r>
            <a:r>
              <a:rPr lang="en-US" dirty="0">
                <a:solidFill>
                  <a:srgbClr val="000000"/>
                </a:solidFill>
                <a:latin typeface="Verdana" panose="020B0604030504040204" pitchFamily="34" charset="0"/>
              </a:rPr>
              <a:t>cas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72845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AB3EFB7-69F8-826F-1791-00B7D5AF54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70311" y="-39103"/>
            <a:ext cx="2954125" cy="3507206"/>
          </a:xfrm>
          <a:prstGeom prst="rect">
            <a:avLst/>
          </a:prstGeom>
          <a:ln>
            <a:solidFill>
              <a:schemeClr val="accent2">
                <a:lumMod val="40000"/>
                <a:lumOff val="60000"/>
              </a:schemeClr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4C59B2B-30DD-A723-89E0-C9AFD892F8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3819" y="0"/>
            <a:ext cx="3496236" cy="3429000"/>
          </a:xfrm>
          <a:prstGeom prst="rect">
            <a:avLst/>
          </a:prstGeom>
          <a:ln>
            <a:solidFill>
              <a:schemeClr val="accent2">
                <a:lumMod val="40000"/>
                <a:lumOff val="60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77A469B-4CC8-59EB-3886-7D70068EB65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59022" y="3517358"/>
            <a:ext cx="2965414" cy="3306886"/>
          </a:xfrm>
          <a:prstGeom prst="rect">
            <a:avLst/>
          </a:prstGeom>
          <a:ln>
            <a:solidFill>
              <a:schemeClr val="accent2">
                <a:lumMod val="40000"/>
                <a:lumOff val="60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A9D0F27-5A4B-90E7-6DBB-5D47AC803C4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63818" y="3539237"/>
            <a:ext cx="3495204" cy="3263128"/>
          </a:xfrm>
          <a:prstGeom prst="rect">
            <a:avLst/>
          </a:prstGeom>
          <a:ln>
            <a:solidFill>
              <a:schemeClr val="accent2">
                <a:lumMod val="40000"/>
                <a:lumOff val="60000"/>
              </a:schemeClr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6C42B7C7-0125-8509-07E2-C851F22510F8}"/>
              </a:ext>
            </a:extLst>
          </p:cNvPr>
          <p:cNvSpPr txBox="1"/>
          <p:nvPr/>
        </p:nvSpPr>
        <p:spPr>
          <a:xfrm>
            <a:off x="8410223" y="2226813"/>
            <a:ext cx="3209418" cy="286232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b="1" dirty="0"/>
              <a:t>Spearman’s correlation(ALDH1A1/MKI67) &gt; </a:t>
            </a:r>
            <a:r>
              <a:rPr lang="en-US" b="1" i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Verdana" panose="020B0604030504040204" pitchFamily="34" charset="0"/>
              </a:rPr>
              <a:t>0.0017 (p=0.971)</a:t>
            </a:r>
            <a:endParaRPr lang="en-US" b="1" dirty="0">
              <a:highlight>
                <a:srgbClr val="FFFF00"/>
              </a:highlight>
            </a:endParaRPr>
          </a:p>
          <a:p>
            <a:endParaRPr lang="en-US" b="1" dirty="0"/>
          </a:p>
          <a:p>
            <a:r>
              <a:rPr lang="en-US" b="1" dirty="0"/>
              <a:t>Criteria of selected samples</a:t>
            </a:r>
          </a:p>
          <a:p>
            <a:r>
              <a:rPr lang="en-US" dirty="0"/>
              <a:t>ER+BC</a:t>
            </a:r>
          </a:p>
          <a:p>
            <a:r>
              <a:rPr lang="en-US" dirty="0"/>
              <a:t>Endocrine therapy received</a:t>
            </a:r>
          </a:p>
          <a:p>
            <a:r>
              <a:rPr lang="en-US" dirty="0">
                <a:solidFill>
                  <a:srgbClr val="C00000"/>
                </a:solidFill>
              </a:rPr>
              <a:t>KI67 negative cases</a:t>
            </a:r>
          </a:p>
          <a:p>
            <a:endParaRPr lang="en-US" dirty="0"/>
          </a:p>
          <a:p>
            <a:r>
              <a:rPr lang="en-US" dirty="0"/>
              <a:t>N =</a:t>
            </a:r>
            <a:r>
              <a:rPr lang="en-US" b="1" dirty="0"/>
              <a:t>456 </a:t>
            </a:r>
            <a:r>
              <a:rPr lang="en-US" b="1" dirty="0">
                <a:solidFill>
                  <a:srgbClr val="000000"/>
                </a:solidFill>
                <a:latin typeface="Verdana" panose="020B0604030504040204" pitchFamily="34" charset="0"/>
              </a:rPr>
              <a:t>case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6837658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CFF146F-3288-A319-2C2C-8C02B82E5692}"/>
              </a:ext>
            </a:extLst>
          </p:cNvPr>
          <p:cNvSpPr txBox="1"/>
          <p:nvPr/>
        </p:nvSpPr>
        <p:spPr>
          <a:xfrm>
            <a:off x="8410223" y="2226813"/>
            <a:ext cx="3209418" cy="286232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/>
              <a:t>Spearman’s correlation(ALDH1A1/MKI67)</a:t>
            </a:r>
          </a:p>
          <a:p>
            <a:r>
              <a:rPr lang="ar-AE" dirty="0"/>
              <a:t>  </a:t>
            </a:r>
            <a:r>
              <a:rPr lang="en-US" i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Verdana" panose="020B0604030504040204" pitchFamily="34" charset="0"/>
              </a:rPr>
              <a:t>-0.0276 (p=0.3191)</a:t>
            </a:r>
          </a:p>
          <a:p>
            <a:endParaRPr lang="en-US" b="1" dirty="0"/>
          </a:p>
          <a:p>
            <a:r>
              <a:rPr lang="en-US" b="1" dirty="0"/>
              <a:t>Criteria of selected samples</a:t>
            </a:r>
          </a:p>
          <a:p>
            <a:r>
              <a:rPr lang="en-US" dirty="0"/>
              <a:t>ER+BC</a:t>
            </a:r>
          </a:p>
          <a:p>
            <a:r>
              <a:rPr lang="en-US" dirty="0"/>
              <a:t>Endocrine therapy received</a:t>
            </a:r>
          </a:p>
          <a:p>
            <a:r>
              <a:rPr lang="en-US" dirty="0">
                <a:solidFill>
                  <a:srgbClr val="C00000"/>
                </a:solidFill>
              </a:rPr>
              <a:t>Luminal A </a:t>
            </a:r>
          </a:p>
          <a:p>
            <a:endParaRPr lang="en-US" dirty="0"/>
          </a:p>
          <a:p>
            <a:r>
              <a:rPr lang="en-US" dirty="0"/>
              <a:t>N =</a:t>
            </a:r>
            <a:r>
              <a:rPr lang="en-US" b="1" dirty="0"/>
              <a:t>1303 </a:t>
            </a:r>
            <a:r>
              <a:rPr lang="en-US" b="1" dirty="0">
                <a:solidFill>
                  <a:srgbClr val="000000"/>
                </a:solidFill>
                <a:latin typeface="Verdana" panose="020B0604030504040204" pitchFamily="34" charset="0"/>
              </a:rPr>
              <a:t>cases</a:t>
            </a:r>
            <a:endParaRPr lang="en-US" b="1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2E8135D-8DF9-97EA-717D-24DF02F9FC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1456" y="0"/>
            <a:ext cx="3327374" cy="3320697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C2E86188-553B-0894-A59B-A387A0A7E98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3093"/>
          <a:stretch/>
        </p:blipFill>
        <p:spPr>
          <a:xfrm>
            <a:off x="1016016" y="-3605"/>
            <a:ext cx="3239826" cy="332430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D9BDAD0-CDFE-0D76-8109-34C1A210A0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01094" y="3384615"/>
            <a:ext cx="3330328" cy="3420114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4585974-440D-EDC0-B64A-8C571A1C98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70765" y="3384615"/>
            <a:ext cx="3330329" cy="3420114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28529023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0291C19-D96B-C4C7-E45E-BBAEE9EFA7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22921" y="52835"/>
            <a:ext cx="2720903" cy="309041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0739F24-3C7F-3164-8604-6565AFD7EB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7440" y="0"/>
            <a:ext cx="3123271" cy="323894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1EF9F20-AE8C-629C-51D7-AFB6BAC608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22921" y="3238948"/>
            <a:ext cx="3012970" cy="342855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CC634E1-F396-E2DC-C1B2-53B9734BD72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023"/>
          <a:stretch/>
        </p:blipFill>
        <p:spPr>
          <a:xfrm>
            <a:off x="1268735" y="3238948"/>
            <a:ext cx="3572240" cy="342855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ECB4B5E-EAB4-6AB1-6C29-7ACAC1CB352E}"/>
              </a:ext>
            </a:extLst>
          </p:cNvPr>
          <p:cNvSpPr txBox="1"/>
          <p:nvPr/>
        </p:nvSpPr>
        <p:spPr>
          <a:xfrm>
            <a:off x="8410223" y="2226813"/>
            <a:ext cx="3209418" cy="286232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/>
              <a:t>Spearman’s correlation(ALDH1A1/MKI67)</a:t>
            </a:r>
          </a:p>
          <a:p>
            <a:r>
              <a:rPr lang="ar-AE" dirty="0"/>
              <a:t>  </a:t>
            </a:r>
            <a:r>
              <a:rPr lang="en-US" b="0" i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Verdana" panose="020B0604030504040204" pitchFamily="34" charset="0"/>
              </a:rPr>
              <a:t>-0.1295 (p=0.0011)</a:t>
            </a:r>
          </a:p>
          <a:p>
            <a:endParaRPr lang="en-US" b="1" dirty="0">
              <a:highlight>
                <a:srgbClr val="FFFF00"/>
              </a:highlight>
            </a:endParaRPr>
          </a:p>
          <a:p>
            <a:r>
              <a:rPr lang="en-US" b="1" dirty="0"/>
              <a:t>Criteria of selected samples</a:t>
            </a:r>
          </a:p>
          <a:p>
            <a:r>
              <a:rPr lang="en-US" dirty="0"/>
              <a:t>ER+BC</a:t>
            </a:r>
          </a:p>
          <a:p>
            <a:r>
              <a:rPr lang="en-US" dirty="0"/>
              <a:t>Endocrine therapy received</a:t>
            </a:r>
          </a:p>
          <a:p>
            <a:r>
              <a:rPr lang="en-US" dirty="0">
                <a:solidFill>
                  <a:srgbClr val="C00000"/>
                </a:solidFill>
              </a:rPr>
              <a:t>Luminal B </a:t>
            </a:r>
          </a:p>
          <a:p>
            <a:endParaRPr lang="en-US" dirty="0"/>
          </a:p>
          <a:p>
            <a:r>
              <a:rPr lang="en-US" dirty="0"/>
              <a:t>N =</a:t>
            </a:r>
            <a:r>
              <a:rPr lang="en-US" b="1" dirty="0"/>
              <a:t>633 </a:t>
            </a:r>
            <a:r>
              <a:rPr lang="en-US" b="1" dirty="0">
                <a:solidFill>
                  <a:srgbClr val="000000"/>
                </a:solidFill>
                <a:latin typeface="Verdana" panose="020B0604030504040204" pitchFamily="34" charset="0"/>
              </a:rPr>
              <a:t>case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9979981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BED408A-660D-007B-0872-5BDEAFF85D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71823" y="0"/>
            <a:ext cx="2610177" cy="315131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EEC8FAB-E95A-1E7F-AD4B-96E9831CFC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76129" y="59234"/>
            <a:ext cx="3619821" cy="345460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B79D209-CE55-9C12-FD3A-DE1CE1A3C2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95950" y="3279880"/>
            <a:ext cx="3147252" cy="345460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FD29658-91C2-9A9F-938B-2B9AE551007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29359" y="3530181"/>
            <a:ext cx="3539777" cy="326858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2566743-5C0C-9419-0C41-B7FA6E976B73}"/>
              </a:ext>
            </a:extLst>
          </p:cNvPr>
          <p:cNvSpPr txBox="1"/>
          <p:nvPr/>
        </p:nvSpPr>
        <p:spPr>
          <a:xfrm>
            <a:off x="8410223" y="2226813"/>
            <a:ext cx="3209418" cy="286232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/>
              <a:t>Spearman’s correlation(ALDH1A1/MKI67)</a:t>
            </a:r>
          </a:p>
          <a:p>
            <a:r>
              <a:rPr lang="ar-AE" dirty="0"/>
              <a:t>  </a:t>
            </a:r>
            <a:r>
              <a:rPr lang="en-US" b="0" i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Verdana" panose="020B0604030504040204" pitchFamily="34" charset="0"/>
              </a:rPr>
              <a:t>-0.0862 (p=0.6005)</a:t>
            </a:r>
          </a:p>
          <a:p>
            <a:endParaRPr lang="en-US" b="1" dirty="0">
              <a:highlight>
                <a:srgbClr val="FFFF00"/>
              </a:highlight>
            </a:endParaRPr>
          </a:p>
          <a:p>
            <a:r>
              <a:rPr lang="en-US" b="1" dirty="0"/>
              <a:t>Criteria of selected samples</a:t>
            </a:r>
          </a:p>
          <a:p>
            <a:r>
              <a:rPr lang="en-US" dirty="0"/>
              <a:t>ER+BC</a:t>
            </a:r>
          </a:p>
          <a:p>
            <a:r>
              <a:rPr lang="en-US" dirty="0"/>
              <a:t>Endocrine therapy received</a:t>
            </a:r>
          </a:p>
          <a:p>
            <a:r>
              <a:rPr lang="en-US" dirty="0">
                <a:solidFill>
                  <a:srgbClr val="C00000"/>
                </a:solidFill>
              </a:rPr>
              <a:t>Basal</a:t>
            </a:r>
          </a:p>
          <a:p>
            <a:endParaRPr lang="en-US" dirty="0"/>
          </a:p>
          <a:p>
            <a:r>
              <a:rPr lang="en-US" dirty="0"/>
              <a:t>N =</a:t>
            </a:r>
            <a:r>
              <a:rPr lang="en-US" b="1" dirty="0">
                <a:highlight>
                  <a:srgbClr val="00FF00"/>
                </a:highlight>
              </a:rPr>
              <a:t>39</a:t>
            </a:r>
            <a:r>
              <a:rPr lang="en-US" b="1" dirty="0"/>
              <a:t> </a:t>
            </a:r>
            <a:r>
              <a:rPr lang="en-US" b="1" dirty="0">
                <a:solidFill>
                  <a:srgbClr val="000000"/>
                </a:solidFill>
                <a:latin typeface="Verdana" panose="020B0604030504040204" pitchFamily="34" charset="0"/>
              </a:rPr>
              <a:t>case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4625342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4C89D18-450A-CA58-FA98-3A01EBF9B8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71548" y="0"/>
            <a:ext cx="3049969" cy="351472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3EB9B13-A28B-B01F-133D-895FB5528F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6284" y="85725"/>
            <a:ext cx="3515264" cy="3429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53C20C2-1F5E-A86F-8AE5-A46BE2A0C3F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08531" y="3676650"/>
            <a:ext cx="2917983" cy="314462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6B2B644-AFB5-F6BD-9A8E-27D25A4D15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21842" y="3514725"/>
            <a:ext cx="3165853" cy="330072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8F016B8-F35A-B537-C58B-65A9526FF0D3}"/>
              </a:ext>
            </a:extLst>
          </p:cNvPr>
          <p:cNvSpPr txBox="1"/>
          <p:nvPr/>
        </p:nvSpPr>
        <p:spPr>
          <a:xfrm>
            <a:off x="8721517" y="1757362"/>
            <a:ext cx="3209418" cy="313932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/>
              <a:t>Spearman’s correlation(ALDH1A1/MKI67)</a:t>
            </a:r>
          </a:p>
          <a:p>
            <a:r>
              <a:rPr lang="ar-AE" dirty="0"/>
              <a:t>  </a:t>
            </a:r>
            <a:r>
              <a:rPr lang="en-US" b="0" i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Verdana" panose="020B0604030504040204" pitchFamily="34" charset="0"/>
              </a:rPr>
              <a:t>-0.1303 (p=0.0387</a:t>
            </a:r>
            <a:endParaRPr lang="en-US" dirty="0">
              <a:highlight>
                <a:srgbClr val="FFFF00"/>
              </a:highlight>
            </a:endParaRPr>
          </a:p>
          <a:p>
            <a:endParaRPr lang="en-US" b="0" i="0" dirty="0">
              <a:solidFill>
                <a:srgbClr val="000000"/>
              </a:solidFill>
              <a:effectLst/>
              <a:highlight>
                <a:srgbClr val="FFFF00"/>
              </a:highlight>
              <a:latin typeface="Verdana" panose="020B0604030504040204" pitchFamily="34" charset="0"/>
            </a:endParaRPr>
          </a:p>
          <a:p>
            <a:endParaRPr lang="en-US" b="1" dirty="0">
              <a:highlight>
                <a:srgbClr val="FFFF00"/>
              </a:highlight>
            </a:endParaRPr>
          </a:p>
          <a:p>
            <a:r>
              <a:rPr lang="en-US" b="1" dirty="0"/>
              <a:t>Criteria of selected samples</a:t>
            </a:r>
          </a:p>
          <a:p>
            <a:r>
              <a:rPr lang="en-US" dirty="0"/>
              <a:t>ER+BC</a:t>
            </a:r>
          </a:p>
          <a:p>
            <a:r>
              <a:rPr lang="en-US" dirty="0"/>
              <a:t>Endocrine therapy received</a:t>
            </a:r>
          </a:p>
          <a:p>
            <a:r>
              <a:rPr lang="en-US" dirty="0">
                <a:solidFill>
                  <a:srgbClr val="C00000"/>
                </a:solidFill>
              </a:rPr>
              <a:t>HER2 POSITIVE</a:t>
            </a:r>
          </a:p>
          <a:p>
            <a:endParaRPr lang="en-US" dirty="0"/>
          </a:p>
          <a:p>
            <a:r>
              <a:rPr lang="en-US" dirty="0"/>
              <a:t>N =</a:t>
            </a:r>
            <a:r>
              <a:rPr lang="en-US" b="1" dirty="0"/>
              <a:t>252 </a:t>
            </a:r>
            <a:r>
              <a:rPr lang="en-US" b="1" dirty="0">
                <a:solidFill>
                  <a:srgbClr val="000000"/>
                </a:solidFill>
                <a:latin typeface="Verdana" panose="020B0604030504040204" pitchFamily="34" charset="0"/>
              </a:rPr>
              <a:t>case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654520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789772D-2DE1-E20C-3A98-367C9C1921C4}"/>
              </a:ext>
            </a:extLst>
          </p:cNvPr>
          <p:cNvSpPr txBox="1"/>
          <p:nvPr/>
        </p:nvSpPr>
        <p:spPr>
          <a:xfrm>
            <a:off x="8721517" y="1757362"/>
            <a:ext cx="3209418" cy="286232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/>
              <a:t>Spearman’s correlation(ALDH1A1/MKI67)</a:t>
            </a:r>
          </a:p>
          <a:p>
            <a:r>
              <a:rPr lang="ar-AE" dirty="0"/>
              <a:t>  </a:t>
            </a:r>
            <a:r>
              <a:rPr lang="en-US" b="0" i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Verdana" panose="020B0604030504040204" pitchFamily="34" charset="0"/>
              </a:rPr>
              <a:t>-0.1593 (p&lt;1E-04)</a:t>
            </a:r>
          </a:p>
          <a:p>
            <a:endParaRPr lang="en-US" b="1" dirty="0">
              <a:highlight>
                <a:srgbClr val="FFFF00"/>
              </a:highlight>
            </a:endParaRPr>
          </a:p>
          <a:p>
            <a:r>
              <a:rPr lang="en-US" b="1" dirty="0"/>
              <a:t>Criteria of selected samples</a:t>
            </a:r>
          </a:p>
          <a:p>
            <a:r>
              <a:rPr lang="en-US" dirty="0"/>
              <a:t>ER+BC</a:t>
            </a:r>
          </a:p>
          <a:p>
            <a:r>
              <a:rPr lang="en-US" dirty="0"/>
              <a:t>Endocrine therapy received</a:t>
            </a:r>
          </a:p>
          <a:p>
            <a:r>
              <a:rPr lang="en-US" dirty="0">
                <a:solidFill>
                  <a:srgbClr val="C00000"/>
                </a:solidFill>
              </a:rPr>
              <a:t>HER2 Negative</a:t>
            </a:r>
          </a:p>
          <a:p>
            <a:endParaRPr lang="en-US" dirty="0"/>
          </a:p>
          <a:p>
            <a:r>
              <a:rPr lang="en-US" dirty="0"/>
              <a:t>N =</a:t>
            </a:r>
            <a:r>
              <a:rPr lang="en-US" b="1" dirty="0"/>
              <a:t>1960 </a:t>
            </a:r>
            <a:r>
              <a:rPr lang="en-US" b="1" dirty="0">
                <a:solidFill>
                  <a:srgbClr val="000000"/>
                </a:solidFill>
                <a:latin typeface="Verdana" panose="020B0604030504040204" pitchFamily="34" charset="0"/>
              </a:rPr>
              <a:t>cases</a:t>
            </a:r>
            <a:endParaRPr lang="en-US" b="1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764F553-A246-3096-307D-D1943C6C58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71750" y="123426"/>
            <a:ext cx="2915709" cy="345054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2FEBE33-F536-6748-509F-D4FF3BED18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06280" y="0"/>
            <a:ext cx="3482330" cy="357397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250AB8F-C2CD-B50B-A417-5BC070B2D7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8610" y="3676282"/>
            <a:ext cx="3041670" cy="305829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C130CF24-4D86-2DC3-330D-B8336D12CF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18899" y="3676282"/>
            <a:ext cx="3102525" cy="31896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71724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0b79772a-82d6-468a-86d6-22ff1101ba48}" enabled="1" method="Privileged" siteId="{e0ba2eba-5425-4d9b-b24b-f0f4845bcf62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67</TotalTime>
  <Words>296</Words>
  <Application>Microsoft Office PowerPoint</Application>
  <PresentationFormat>Widescreen</PresentationFormat>
  <Paragraphs>87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Verdana</vt:lpstr>
      <vt:lpstr>Office Theme</vt:lpstr>
      <vt:lpstr>Supplemental Dat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O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Data</dc:title>
  <dc:creator>Noha Ahmed Mousa</dc:creator>
  <cp:lastModifiedBy>Noha Ahmed Mousa</cp:lastModifiedBy>
  <cp:revision>1</cp:revision>
  <dcterms:created xsi:type="dcterms:W3CDTF">2024-01-10T09:43:14Z</dcterms:created>
  <dcterms:modified xsi:type="dcterms:W3CDTF">2024-01-12T06:30:09Z</dcterms:modified>
</cp:coreProperties>
</file>